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63" r:id="rId2"/>
    <p:sldId id="261" r:id="rId3"/>
    <p:sldId id="262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00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581" autoAdjust="0"/>
  </p:normalViewPr>
  <p:slideViewPr>
    <p:cSldViewPr snapToGrid="0">
      <p:cViewPr varScale="1">
        <p:scale>
          <a:sx n="56" d="100"/>
          <a:sy n="56" d="100"/>
        </p:scale>
        <p:origin x="216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хний колонтитул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116F7D7-3BB3-41BB-ACFB-4D0057841DDA}" type="datetimeFigureOut">
              <a:rPr lang="ru-RU" smtClean="0"/>
              <a:t>07.12.2023</a:t>
            </a:fld>
            <a:endParaRPr lang="ru-RU"/>
          </a:p>
        </p:txBody>
      </p:sp>
      <p:sp>
        <p:nvSpPr>
          <p:cNvPr id="4" name="Образ слайда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ru-RU"/>
          </a:p>
        </p:txBody>
      </p:sp>
      <p:sp>
        <p:nvSpPr>
          <p:cNvPr id="5" name="Заметки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B6AAE2D-D723-4FEC-B239-86680B035502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4042299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Образ слайда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Заметки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B6AAE2D-D723-4FEC-B239-86680B035502}" type="slidenum">
              <a:rPr lang="ru-RU" smtClean="0"/>
              <a:t>1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8901453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Образ слайда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Заметки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B6AAE2D-D723-4FEC-B239-86680B035502}" type="slidenum">
              <a:rPr lang="ru-RU" smtClean="0"/>
              <a:t>2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88245278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Образ слайда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Заметки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B6AAE2D-D723-4FEC-B239-86680B035502}" type="slidenum">
              <a:rPr lang="ru-RU" smtClean="0"/>
              <a:t>3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99790703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altLang="zh-CN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076FE-B78C-4157-A958-8691F5290EE6}" type="datetimeFigureOut">
              <a:rPr lang="zh-CN" altLang="en-US" smtClean="0"/>
              <a:t>2023/12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4EBBC-F1C4-45B5-A4DB-6905CC1138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48671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076FE-B78C-4157-A958-8691F5290EE6}" type="datetimeFigureOut">
              <a:rPr lang="zh-CN" altLang="en-US" smtClean="0"/>
              <a:t>2023/12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4EBBC-F1C4-45B5-A4DB-6905CC1138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24778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076FE-B78C-4157-A958-8691F5290EE6}" type="datetimeFigureOut">
              <a:rPr lang="zh-CN" altLang="en-US" smtClean="0"/>
              <a:t>2023/12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4EBBC-F1C4-45B5-A4DB-6905CC1138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026206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076FE-B78C-4157-A958-8691F5290EE6}" type="datetimeFigureOut">
              <a:rPr lang="zh-CN" altLang="en-US" smtClean="0"/>
              <a:t>2023/12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4EBBC-F1C4-45B5-A4DB-6905CC1138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809242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076FE-B78C-4157-A958-8691F5290EE6}" type="datetimeFigureOut">
              <a:rPr lang="zh-CN" altLang="en-US" smtClean="0"/>
              <a:t>2023/12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4EBBC-F1C4-45B5-A4DB-6905CC1138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865811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076FE-B78C-4157-A958-8691F5290EE6}" type="datetimeFigureOut">
              <a:rPr lang="zh-CN" altLang="en-US" smtClean="0"/>
              <a:t>2023/12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4EBBC-F1C4-45B5-A4DB-6905CC1138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770394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076FE-B78C-4157-A958-8691F5290EE6}" type="datetimeFigureOut">
              <a:rPr lang="zh-CN" altLang="en-US" smtClean="0"/>
              <a:t>2023/12/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4EBBC-F1C4-45B5-A4DB-6905CC1138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679591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076FE-B78C-4157-A958-8691F5290EE6}" type="datetimeFigureOut">
              <a:rPr lang="zh-CN" altLang="en-US" smtClean="0"/>
              <a:t>2023/12/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4EBBC-F1C4-45B5-A4DB-6905CC1138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483311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076FE-B78C-4157-A958-8691F5290EE6}" type="datetimeFigureOut">
              <a:rPr lang="zh-CN" altLang="en-US" smtClean="0"/>
              <a:t>2023/12/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4EBBC-F1C4-45B5-A4DB-6905CC1138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616529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076FE-B78C-4157-A958-8691F5290EE6}" type="datetimeFigureOut">
              <a:rPr lang="zh-CN" altLang="en-US" smtClean="0"/>
              <a:t>2023/12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4EBBC-F1C4-45B5-A4DB-6905CC1138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329452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altLang="zh-CN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076FE-B78C-4157-A958-8691F5290EE6}" type="datetimeFigureOut">
              <a:rPr lang="zh-CN" altLang="en-US" smtClean="0"/>
              <a:t>2023/12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4EBBC-F1C4-45B5-A4DB-6905CC1138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740873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8076FE-B78C-4157-A958-8691F5290EE6}" type="datetimeFigureOut">
              <a:rPr lang="zh-CN" altLang="en-US" smtClean="0"/>
              <a:t>2023/12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14EBBC-F1C4-45B5-A4DB-6905CC1138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99581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3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5" Type="http://schemas.openxmlformats.org/officeDocument/2006/relationships/image" Target="../media/image3.emf"/><Relationship Id="rId4" Type="http://schemas.openxmlformats.org/officeDocument/2006/relationships/oleObject" Target="../embeddings/oleObject3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DFBD2BF1-06B2-F04E-4DD2-EEF00C3E7B78}"/>
              </a:ext>
            </a:extLst>
          </p:cNvPr>
          <p:cNvSpPr txBox="1"/>
          <p:nvPr/>
        </p:nvSpPr>
        <p:spPr>
          <a:xfrm>
            <a:off x="0" y="8392318"/>
            <a:ext cx="6858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 Structures and isomer composition </a:t>
            </a:r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altLang="zh-CN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roxides</a:t>
            </a:r>
            <a:endParaRPr lang="en-US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7" name="Объект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39170395"/>
              </p:ext>
            </p:extLst>
          </p:nvPr>
        </p:nvGraphicFramePr>
        <p:xfrm>
          <a:off x="69011" y="163902"/>
          <a:ext cx="6685472" cy="81528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1" name="CS ChemDraw Drawing" r:id="rId4" imgW="8150352" imgH="9931908" progId="ChemDraw.Document.6.0">
                  <p:embed/>
                </p:oleObj>
              </mc:Choice>
              <mc:Fallback>
                <p:oleObj name="CS ChemDraw Drawing" r:id="rId4" imgW="8150352" imgH="9931908" progId="ChemDraw.Document.6.0">
                  <p:embed/>
                  <p:pic>
                    <p:nvPicPr>
                      <p:cNvPr id="0" name="Object 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9011" y="163902"/>
                        <a:ext cx="6685472" cy="8152840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0844271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CDEC004E-525B-4324-98AD-753290BEBBAA}"/>
              </a:ext>
            </a:extLst>
          </p:cNvPr>
          <p:cNvSpPr txBox="1"/>
          <p:nvPr/>
        </p:nvSpPr>
        <p:spPr>
          <a:xfrm>
            <a:off x="0" y="8188036"/>
            <a:ext cx="68580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 BLI binding kinetics measurement of hits.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r>
              <a:rPr lang="en-US" altLang="zh-CN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lues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e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own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an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± SEM.</a:t>
            </a:r>
          </a:p>
          <a:p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xmlns="" id="{D5582354-A3D8-4EC4-BA97-00052FE934B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72560562"/>
              </p:ext>
            </p:extLst>
          </p:nvPr>
        </p:nvGraphicFramePr>
        <p:xfrm>
          <a:off x="488091" y="222421"/>
          <a:ext cx="5871417" cy="282969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3" name="Prism 8" r:id="rId4" imgW="9402006" imgH="4524358" progId="Prism8.Document">
                  <p:embed/>
                </p:oleObj>
              </mc:Choice>
              <mc:Fallback>
                <p:oleObj name="Prism 8" r:id="rId4" imgW="9402006" imgH="4524358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88091" y="222421"/>
                        <a:ext cx="5871417" cy="282969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F8B78F6B-701E-4950-8E34-6A8C47AB872A}"/>
              </a:ext>
            </a:extLst>
          </p:cNvPr>
          <p:cNvSpPr txBox="1"/>
          <p:nvPr/>
        </p:nvSpPr>
        <p:spPr>
          <a:xfrm>
            <a:off x="2704585" y="1413533"/>
            <a:ext cx="14384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K</a:t>
            </a:r>
            <a:r>
              <a:rPr lang="en-US" altLang="zh-CN" sz="1000" baseline="-25000" dirty="0"/>
              <a:t>D</a:t>
            </a:r>
            <a:r>
              <a:rPr lang="en-US" altLang="zh-CN" sz="1000" dirty="0"/>
              <a:t> = 29.69±1.48 </a:t>
            </a:r>
            <a:r>
              <a:rPr lang="en-US" altLang="zh-CN" sz="1000" dirty="0" err="1"/>
              <a:t>μM</a:t>
            </a:r>
            <a:endParaRPr lang="zh-CN" altLang="en-US" sz="1000" dirty="0"/>
          </a:p>
        </p:txBody>
      </p:sp>
    </p:spTree>
    <p:extLst>
      <p:ext uri="{BB962C8B-B14F-4D97-AF65-F5344CB8AC3E}">
        <p14:creationId xmlns:p14="http://schemas.microsoft.com/office/powerpoint/2010/main" val="32950915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89924549-7AD9-4C1C-87A2-C539B06F9AE2}"/>
              </a:ext>
            </a:extLst>
          </p:cNvPr>
          <p:cNvSpPr txBox="1"/>
          <p:nvPr/>
        </p:nvSpPr>
        <p:spPr>
          <a:xfrm>
            <a:off x="0" y="8188036"/>
            <a:ext cx="6858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 Cytotoxicity assay of hits</a:t>
            </a:r>
          </a:p>
          <a:p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xmlns="" id="{6A725BE8-C1B4-41CF-B3BF-F6CD84B84FF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87892474"/>
              </p:ext>
            </p:extLst>
          </p:nvPr>
        </p:nvGraphicFramePr>
        <p:xfrm>
          <a:off x="85725" y="61983"/>
          <a:ext cx="6686550" cy="20193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7" name="Prism 8" r:id="rId4" imgW="8018342" imgH="2413903" progId="Prism8.Document">
                  <p:embed/>
                </p:oleObj>
              </mc:Choice>
              <mc:Fallback>
                <p:oleObj name="Prism 8" r:id="rId4" imgW="8018342" imgH="2413903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85725" y="61983"/>
                        <a:ext cx="6686550" cy="20193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5855862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Стандартная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79</TotalTime>
  <Words>39</Words>
  <Application>Microsoft Office PowerPoint</Application>
  <PresentationFormat>Лист A4 (210x297 мм)</PresentationFormat>
  <Paragraphs>7</Paragraphs>
  <Slides>3</Slides>
  <Notes>3</Notes>
  <HiddenSlides>0</HiddenSlides>
  <MMClips>0</MMClips>
  <ScaleCrop>false</ScaleCrop>
  <HeadingPairs>
    <vt:vector size="8" baseType="variant">
      <vt:variant>
        <vt:lpstr>Использованные шрифты</vt:lpstr>
      </vt:variant>
      <vt:variant>
        <vt:i4>6</vt:i4>
      </vt:variant>
      <vt:variant>
        <vt:lpstr>Тема</vt:lpstr>
      </vt:variant>
      <vt:variant>
        <vt:i4>1</vt:i4>
      </vt:variant>
      <vt:variant>
        <vt:lpstr>Внедренные серверы OLE</vt:lpstr>
      </vt:variant>
      <vt:variant>
        <vt:i4>2</vt:i4>
      </vt:variant>
      <vt:variant>
        <vt:lpstr>Заголовки слайдов</vt:lpstr>
      </vt:variant>
      <vt:variant>
        <vt:i4>3</vt:i4>
      </vt:variant>
    </vt:vector>
  </HeadingPairs>
  <TitlesOfParts>
    <vt:vector size="12" baseType="lpstr">
      <vt:lpstr>等线</vt:lpstr>
      <vt:lpstr>等线 Light</vt:lpstr>
      <vt:lpstr>Arial</vt:lpstr>
      <vt:lpstr>Calibri</vt:lpstr>
      <vt:lpstr>Calibri Light</vt:lpstr>
      <vt:lpstr>Times New Roman</vt:lpstr>
      <vt:lpstr>Office Theme</vt:lpstr>
      <vt:lpstr>CS ChemDraw Drawing</vt:lpstr>
      <vt:lpstr>Prism 8</vt:lpstr>
      <vt:lpstr>Презентация PowerPoint</vt:lpstr>
      <vt:lpstr>Презентация PowerPoint</vt:lpstr>
      <vt:lpstr>Презентация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ingqi Zhang</dc:creator>
  <cp:lastModifiedBy>Ivan</cp:lastModifiedBy>
  <cp:revision>37</cp:revision>
  <cp:lastPrinted>2022-11-10T15:22:28Z</cp:lastPrinted>
  <dcterms:created xsi:type="dcterms:W3CDTF">2022-03-17T06:10:15Z</dcterms:created>
  <dcterms:modified xsi:type="dcterms:W3CDTF">2023-12-07T08:06:25Z</dcterms:modified>
</cp:coreProperties>
</file>